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6859588" cy="8004175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22">
          <p15:clr>
            <a:srgbClr val="A4A3A4"/>
          </p15:clr>
        </p15:guide>
        <p15:guide id="2" pos="216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29" autoAdjust="0"/>
  </p:normalViewPr>
  <p:slideViewPr>
    <p:cSldViewPr>
      <p:cViewPr varScale="1">
        <p:scale>
          <a:sx n="82" d="100"/>
          <a:sy n="82" d="100"/>
        </p:scale>
        <p:origin x="2488" y="44"/>
      </p:cViewPr>
      <p:guideLst>
        <p:guide orient="horz" pos="2522"/>
        <p:guide pos="21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Johannes\_Mob2%20vir88%20_%205971\Infektionen\2016-6-20%20infektion%20vir88%203%20dpi\zahlen%20deformed%20ap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Johannes\_Mob2%20vir88%20_%205971\Appressorienbildung\2016-6-7%20vir88%20aps\ausz&#228;hlung%20apppressorien%20vir88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Johannes\_Mob2%20vir88%20_%205971\Infektionen\2016-6-20%20infektion%20vir88%203%20dpi\zahlen%20deformed%20ap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548240740740742"/>
          <c:y val="2.626712962962963E-2"/>
          <c:w val="0.48530462962962956"/>
          <c:h val="0.94746574074074075"/>
        </c:manualLayout>
      </c:layout>
      <c:barChart>
        <c:barDir val="col"/>
        <c:grouping val="percentStacked"/>
        <c:varyColors val="0"/>
        <c:ser>
          <c:idx val="1"/>
          <c:order val="0"/>
          <c:tx>
            <c:v>%PH from deformed AP</c:v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('23d'!$AP$6;'23d'!$AP$14)</c:f>
                <c:numCache>
                  <c:formatCode>General</c:formatCode>
                  <c:ptCount val="2"/>
                  <c:pt idx="0">
                    <c:v>2.5572487091351015E-2</c:v>
                  </c:pt>
                  <c:pt idx="1">
                    <c:v>5.8515181428854729E-2</c:v>
                  </c:pt>
                </c:numCache>
              </c:numRef>
            </c:plus>
            <c:minus>
              <c:numRef>
                <c:f>('23d'!$AP$6;'23d'!$AP$14)</c:f>
                <c:numCache>
                  <c:formatCode>General</c:formatCode>
                  <c:ptCount val="2"/>
                  <c:pt idx="0">
                    <c:v>2.5572487091351015E-2</c:v>
                  </c:pt>
                  <c:pt idx="1">
                    <c:v>5.8515181428854729E-2</c:v>
                  </c:pt>
                </c:numCache>
              </c:numRef>
            </c:minus>
            <c:spPr>
              <a:ln w="19050" cap="flat">
                <a:solidFill>
                  <a:schemeClr val="bg1"/>
                </a:solidFill>
                <a:miter lim="800000"/>
              </a:ln>
            </c:spPr>
          </c:errBars>
          <c:val>
            <c:numRef>
              <c:f>('23d'!$AR$6;'23d'!$AR$14)</c:f>
              <c:numCache>
                <c:formatCode>00,000</c:formatCode>
                <c:ptCount val="2"/>
                <c:pt idx="0" formatCode="#,#00%">
                  <c:v>0.11007072006626846</c:v>
                </c:pt>
                <c:pt idx="1">
                  <c:v>0.130627629733520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F30-4057-B2E7-168A39D53D3E}"/>
            </c:ext>
          </c:extLst>
        </c:ser>
        <c:ser>
          <c:idx val="0"/>
          <c:order val="1"/>
          <c:tx>
            <c:v>%PH from normal AP</c:v>
          </c:tx>
          <c:spPr>
            <a:solidFill>
              <a:schemeClr val="tx1"/>
            </a:solidFill>
          </c:spPr>
          <c:invertIfNegative val="0"/>
          <c:cat>
            <c:strRef>
              <c:f>('23d'!$AM$4;'23d'!$AM$12)</c:f>
              <c:strCache>
                <c:ptCount val="2"/>
                <c:pt idx="0">
                  <c:v>wt</c:v>
                </c:pt>
                <c:pt idx="1">
                  <c:v>vir-88</c:v>
                </c:pt>
              </c:strCache>
            </c:strRef>
          </c:cat>
          <c:val>
            <c:numRef>
              <c:f>('23d'!$AN$6;'23d'!$AN$14)</c:f>
              <c:numCache>
                <c:formatCode>00,000</c:formatCode>
                <c:ptCount val="2"/>
                <c:pt idx="0" formatCode="#,#00%">
                  <c:v>0.8899292799337315</c:v>
                </c:pt>
                <c:pt idx="1">
                  <c:v>0.869372370266479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F30-4057-B2E7-168A39D53D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7918080"/>
        <c:axId val="87919616"/>
      </c:barChart>
      <c:catAx>
        <c:axId val="87918080"/>
        <c:scaling>
          <c:orientation val="minMax"/>
        </c:scaling>
        <c:delete val="1"/>
        <c:axPos val="b"/>
        <c:majorTickMark val="out"/>
        <c:minorTickMark val="none"/>
        <c:tickLblPos val="nextTo"/>
        <c:crossAx val="87919616"/>
        <c:crosses val="autoZero"/>
        <c:auto val="1"/>
        <c:lblAlgn val="ctr"/>
        <c:lblOffset val="100"/>
        <c:noMultiLvlLbl val="0"/>
      </c:catAx>
      <c:valAx>
        <c:axId val="87919616"/>
        <c:scaling>
          <c:orientation val="minMax"/>
          <c:max val="1"/>
          <c:min val="0"/>
        </c:scaling>
        <c:delete val="0"/>
        <c:axPos val="l"/>
        <c:majorGridlines>
          <c:spPr>
            <a:ln w="12700">
              <a:solidFill>
                <a:schemeClr val="tx1"/>
              </a:solidFill>
            </a:ln>
          </c:spPr>
        </c:majorGridlines>
        <c:numFmt formatCode="0%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7918080"/>
        <c:crosses val="autoZero"/>
        <c:crossBetween val="between"/>
        <c:majorUnit val="0.2"/>
      </c:valAx>
    </c:plotArea>
    <c:legend>
      <c:legendPos val="r"/>
      <c:layout>
        <c:manualLayout>
          <c:xMode val="edge"/>
          <c:yMode val="edge"/>
          <c:x val="0.6843055555555555"/>
          <c:y val="0.16079722222222223"/>
          <c:w val="0.30981481481481482"/>
          <c:h val="0.3667851851851851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60277777777777"/>
          <c:y val="2.626712962962963E-2"/>
          <c:w val="0.48639907407407407"/>
          <c:h val="0.94746574074074075"/>
        </c:manualLayout>
      </c:layout>
      <c:barChart>
        <c:barDir val="col"/>
        <c:grouping val="percentStacked"/>
        <c:varyColors val="0"/>
        <c:ser>
          <c:idx val="1"/>
          <c:order val="0"/>
          <c:tx>
            <c:v>%deformed AP</c:v>
          </c:tx>
          <c:spPr>
            <a:solidFill>
              <a:schemeClr val="bg1">
                <a:lumMod val="50000"/>
              </a:schemeClr>
            </a:solidFill>
          </c:spPr>
          <c:invertIfNegative val="0"/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BAC0-4D8E-B7C0-E557769C4F00}"/>
              </c:ext>
            </c:extLst>
          </c:dPt>
          <c:errBars>
            <c:errBarType val="both"/>
            <c:errValType val="cust"/>
            <c:noEndCap val="0"/>
            <c:plus>
              <c:numRef>
                <c:f>(Tabelle1!$Z$10;Tabelle1!$Z$22)</c:f>
                <c:numCache>
                  <c:formatCode>General</c:formatCode>
                  <c:ptCount val="2"/>
                  <c:pt idx="0">
                    <c:v>1.7050503792964241E-2</c:v>
                  </c:pt>
                  <c:pt idx="1">
                    <c:v>1.3066845422565775E-2</c:v>
                  </c:pt>
                </c:numCache>
              </c:numRef>
            </c:plus>
            <c:minus>
              <c:numRef>
                <c:f>(Tabelle1!$Z$10;Tabelle1!$Z$22)</c:f>
                <c:numCache>
                  <c:formatCode>General</c:formatCode>
                  <c:ptCount val="2"/>
                  <c:pt idx="0">
                    <c:v>1.7050503792964241E-2</c:v>
                  </c:pt>
                  <c:pt idx="1">
                    <c:v>1.3066845422565775E-2</c:v>
                  </c:pt>
                </c:numCache>
              </c:numRef>
            </c:minus>
            <c:spPr>
              <a:ln w="19050" cap="flat">
                <a:solidFill>
                  <a:schemeClr val="bg1"/>
                </a:solidFill>
                <a:miter lim="800000"/>
              </a:ln>
            </c:spPr>
          </c:errBars>
          <c:cat>
            <c:strRef>
              <c:f>(Tabelle1!$W$7;Tabelle1!$W$19)</c:f>
              <c:strCache>
                <c:ptCount val="2"/>
                <c:pt idx="0">
                  <c:v>WT</c:v>
                </c:pt>
                <c:pt idx="1">
                  <c:v>vir-88</c:v>
                </c:pt>
              </c:strCache>
            </c:strRef>
          </c:cat>
          <c:val>
            <c:numRef>
              <c:f>(Tabelle1!$AA$9;Tabelle1!$AA$21)</c:f>
              <c:numCache>
                <c:formatCode>General</c:formatCode>
                <c:ptCount val="2"/>
                <c:pt idx="0">
                  <c:v>7.9545454545454544E-2</c:v>
                </c:pt>
                <c:pt idx="1">
                  <c:v>0.643652561247216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AC0-4D8E-B7C0-E557769C4F00}"/>
            </c:ext>
          </c:extLst>
        </c:ser>
        <c:ser>
          <c:idx val="0"/>
          <c:order val="1"/>
          <c:tx>
            <c:v>%normal AP</c:v>
          </c:tx>
          <c:spPr>
            <a:solidFill>
              <a:schemeClr val="tx1"/>
            </a:solidFill>
          </c:spPr>
          <c:invertIfNegative val="0"/>
          <c:cat>
            <c:strRef>
              <c:f>(Tabelle1!$W$7;Tabelle1!$W$19)</c:f>
              <c:strCache>
                <c:ptCount val="2"/>
                <c:pt idx="0">
                  <c:v>WT</c:v>
                </c:pt>
                <c:pt idx="1">
                  <c:v>vir-88</c:v>
                </c:pt>
              </c:strCache>
            </c:strRef>
          </c:cat>
          <c:val>
            <c:numRef>
              <c:f>(Tabelle1!$Z$9;Tabelle1!$Z$21)</c:f>
              <c:numCache>
                <c:formatCode>General</c:formatCode>
                <c:ptCount val="2"/>
                <c:pt idx="0">
                  <c:v>0.92045454545454541</c:v>
                </c:pt>
                <c:pt idx="1">
                  <c:v>0.356347438752783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AC0-4D8E-B7C0-E557769C4F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7957888"/>
        <c:axId val="87959424"/>
      </c:barChart>
      <c:catAx>
        <c:axId val="879578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7959424"/>
        <c:crosses val="autoZero"/>
        <c:auto val="1"/>
        <c:lblAlgn val="ctr"/>
        <c:lblOffset val="100"/>
        <c:noMultiLvlLbl val="0"/>
      </c:catAx>
      <c:valAx>
        <c:axId val="87959424"/>
        <c:scaling>
          <c:orientation val="minMax"/>
        </c:scaling>
        <c:delete val="0"/>
        <c:axPos val="l"/>
        <c:majorGridlines>
          <c:spPr>
            <a:ln w="12700">
              <a:solidFill>
                <a:schemeClr val="tx1"/>
              </a:solidFill>
            </a:ln>
          </c:spPr>
        </c:majorGridlines>
        <c:numFmt formatCode="0%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7957888"/>
        <c:crosses val="autoZero"/>
        <c:crossBetween val="between"/>
        <c:majorUnit val="0.2"/>
      </c:valAx>
    </c:plotArea>
    <c:legend>
      <c:legendPos val="r"/>
      <c:layout>
        <c:manualLayout>
          <c:xMode val="edge"/>
          <c:yMode val="edge"/>
          <c:x val="0.64424259259259264"/>
          <c:y val="0.10788055555555555"/>
          <c:w val="0.34399814814814816"/>
          <c:h val="0.4138222222222222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960277777777777"/>
          <c:y val="2.626712962962963E-2"/>
          <c:w val="0.49165092592592591"/>
          <c:h val="0.94746574074074075"/>
        </c:manualLayout>
      </c:layout>
      <c:barChart>
        <c:barDir val="col"/>
        <c:grouping val="percentStacked"/>
        <c:varyColors val="0"/>
        <c:ser>
          <c:idx val="1"/>
          <c:order val="0"/>
          <c:tx>
            <c:v>%deformed AP</c:v>
          </c:tx>
          <c:spPr>
            <a:solidFill>
              <a:schemeClr val="bg1">
                <a:lumMod val="50000"/>
              </a:schemeClr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23d'!$AT$29,'23d'!$AT$37)</c:f>
                <c:numCache>
                  <c:formatCode>General</c:formatCode>
                  <c:ptCount val="2"/>
                  <c:pt idx="0">
                    <c:v>1.8951858287839934E-2</c:v>
                  </c:pt>
                  <c:pt idx="1">
                    <c:v>2.3232105469196036E-2</c:v>
                  </c:pt>
                </c:numCache>
              </c:numRef>
            </c:plus>
            <c:minus>
              <c:numRef>
                <c:f>('23d'!$AT$29,'23d'!$AT$37)</c:f>
                <c:numCache>
                  <c:formatCode>General</c:formatCode>
                  <c:ptCount val="2"/>
                  <c:pt idx="0">
                    <c:v>1.8951858287839934E-2</c:v>
                  </c:pt>
                  <c:pt idx="1">
                    <c:v>2.3232105469196036E-2</c:v>
                  </c:pt>
                </c:numCache>
              </c:numRef>
            </c:minus>
            <c:spPr>
              <a:ln w="19050" cap="flat">
                <a:solidFill>
                  <a:schemeClr val="bg1"/>
                </a:solidFill>
                <a:miter lim="800000"/>
              </a:ln>
            </c:spPr>
          </c:errBars>
          <c:cat>
            <c:strRef>
              <c:f>('23d'!$AM$27,'23d'!$AM$35)</c:f>
              <c:strCache>
                <c:ptCount val="2"/>
                <c:pt idx="0">
                  <c:v>wt</c:v>
                </c:pt>
                <c:pt idx="1">
                  <c:v>vir-88</c:v>
                </c:pt>
              </c:strCache>
            </c:strRef>
          </c:cat>
          <c:val>
            <c:numRef>
              <c:f>('23d'!$AR$29,'23d'!$AR$37)</c:f>
              <c:numCache>
                <c:formatCode>General</c:formatCode>
                <c:ptCount val="2"/>
                <c:pt idx="0">
                  <c:v>0.10583375853167498</c:v>
                </c:pt>
                <c:pt idx="1">
                  <c:v>0.624808493307265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E0-4BE7-8504-B169DD9EFCA0}"/>
            </c:ext>
          </c:extLst>
        </c:ser>
        <c:ser>
          <c:idx val="0"/>
          <c:order val="1"/>
          <c:tx>
            <c:v>%normal AP</c:v>
          </c:tx>
          <c:spPr>
            <a:solidFill>
              <a:schemeClr val="tx1"/>
            </a:solidFill>
          </c:spPr>
          <c:invertIfNegative val="0"/>
          <c:cat>
            <c:strRef>
              <c:f>('23d'!$AM$27,'23d'!$AM$35)</c:f>
              <c:strCache>
                <c:ptCount val="2"/>
                <c:pt idx="0">
                  <c:v>wt</c:v>
                </c:pt>
                <c:pt idx="1">
                  <c:v>vir-88</c:v>
                </c:pt>
              </c:strCache>
            </c:strRef>
          </c:cat>
          <c:val>
            <c:numRef>
              <c:f>('23d'!$AN$29,'23d'!$AN$37)</c:f>
              <c:numCache>
                <c:formatCode>General</c:formatCode>
                <c:ptCount val="2"/>
                <c:pt idx="0">
                  <c:v>0.89416624146832502</c:v>
                </c:pt>
                <c:pt idx="1">
                  <c:v>0.375191506692734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E0-4BE7-8504-B169DD9EFC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7972480"/>
        <c:axId val="87982464"/>
      </c:barChart>
      <c:catAx>
        <c:axId val="87972480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87982464"/>
        <c:crosses val="autoZero"/>
        <c:auto val="1"/>
        <c:lblAlgn val="ctr"/>
        <c:lblOffset val="100"/>
        <c:noMultiLvlLbl val="0"/>
      </c:catAx>
      <c:valAx>
        <c:axId val="87982464"/>
        <c:scaling>
          <c:orientation val="minMax"/>
        </c:scaling>
        <c:delete val="0"/>
        <c:axPos val="l"/>
        <c:majorGridlines>
          <c:spPr>
            <a:ln w="12700">
              <a:solidFill>
                <a:schemeClr val="tx1"/>
              </a:solidFill>
            </a:ln>
          </c:spPr>
        </c:majorGridlines>
        <c:numFmt formatCode="0%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de-DE"/>
          </a:p>
        </c:txPr>
        <c:crossAx val="87972480"/>
        <c:crosses val="autoZero"/>
        <c:crossBetween val="between"/>
        <c:majorUnit val="0.2"/>
      </c:valAx>
    </c:plotArea>
    <c:legend>
      <c:legendPos val="r"/>
      <c:layout>
        <c:manualLayout>
          <c:xMode val="edge"/>
          <c:yMode val="edge"/>
          <c:x val="0.64878379629629634"/>
          <c:y val="0.10697268518518518"/>
          <c:w val="0.33945694444444446"/>
          <c:h val="0.41563796296296296"/>
        </c:manualLayout>
      </c:layout>
      <c:overlay val="0"/>
      <c:txPr>
        <a:bodyPr/>
        <a:lstStyle/>
        <a:p>
          <a:pPr>
            <a:defRPr sz="800"/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DC305B-D344-444D-9568-68745DF13A2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804988" y="744538"/>
            <a:ext cx="3187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DDAA95-6386-469F-AB03-5CBBFCAF28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18423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DDAA95-6386-469F-AB03-5CBBFCAF2879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24483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469" y="2486485"/>
            <a:ext cx="5830650" cy="171570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938" y="4535699"/>
            <a:ext cx="4801712" cy="204551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3201" y="320539"/>
            <a:ext cx="1543407" cy="6829488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80" y="320539"/>
            <a:ext cx="4515895" cy="6829488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860" y="5143424"/>
            <a:ext cx="5830650" cy="158971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860" y="3392512"/>
            <a:ext cx="5830650" cy="175091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80" y="1867642"/>
            <a:ext cx="3029651" cy="528238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957" y="1867642"/>
            <a:ext cx="3029651" cy="528238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79" y="1791678"/>
            <a:ext cx="3030843" cy="7466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79" y="2538363"/>
            <a:ext cx="3030843" cy="46116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77" y="1791678"/>
            <a:ext cx="3032033" cy="7466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77" y="2538363"/>
            <a:ext cx="3032033" cy="46116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81" y="318686"/>
            <a:ext cx="2256757" cy="135626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908" y="318687"/>
            <a:ext cx="3834700" cy="683134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81" y="1674949"/>
            <a:ext cx="2256757" cy="54750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527" y="5602924"/>
            <a:ext cx="4115753" cy="66145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527" y="715190"/>
            <a:ext cx="4115753" cy="480250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527" y="6264379"/>
            <a:ext cx="4115753" cy="9393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80" y="320538"/>
            <a:ext cx="6173629" cy="13340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80" y="1867642"/>
            <a:ext cx="6173629" cy="52823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79" y="7418685"/>
            <a:ext cx="1600571" cy="4261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0.01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693" y="7418685"/>
            <a:ext cx="2172203" cy="4261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6038" y="7418685"/>
            <a:ext cx="1600571" cy="42614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jpeg"/><Relationship Id="rId13" Type="http://schemas.microsoft.com/office/2007/relationships/hdphoto" Target="../media/hdphoto4.wdp"/><Relationship Id="rId3" Type="http://schemas.openxmlformats.org/officeDocument/2006/relationships/chart" Target="../charts/chart1.xml"/><Relationship Id="rId7" Type="http://schemas.microsoft.com/office/2007/relationships/hdphoto" Target="../media/hdphoto1.wdp"/><Relationship Id="rId12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jpeg"/><Relationship Id="rId11" Type="http://schemas.microsoft.com/office/2007/relationships/hdphoto" Target="../media/hdphoto3.wdp"/><Relationship Id="rId5" Type="http://schemas.openxmlformats.org/officeDocument/2006/relationships/chart" Target="../charts/chart3.xml"/><Relationship Id="rId10" Type="http://schemas.openxmlformats.org/officeDocument/2006/relationships/image" Target="../media/image3.jpeg"/><Relationship Id="rId4" Type="http://schemas.openxmlformats.org/officeDocument/2006/relationships/chart" Target="../charts/chart2.xml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Diagramm 4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58797"/>
              </p:ext>
            </p:extLst>
          </p:nvPr>
        </p:nvGraphicFramePr>
        <p:xfrm>
          <a:off x="2434489" y="2493684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5" name="Gruppieren 4"/>
          <p:cNvGrpSpPr/>
          <p:nvPr/>
        </p:nvGrpSpPr>
        <p:grpSpPr>
          <a:xfrm>
            <a:off x="4439356" y="2129879"/>
            <a:ext cx="2386631" cy="2710059"/>
            <a:chOff x="-96532" y="2129879"/>
            <a:chExt cx="2386631" cy="2710059"/>
          </a:xfrm>
        </p:grpSpPr>
        <p:graphicFrame>
          <p:nvGraphicFramePr>
            <p:cNvPr id="27" name="Diagramm 2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20013959"/>
                </p:ext>
              </p:extLst>
            </p:nvPr>
          </p:nvGraphicFramePr>
          <p:xfrm>
            <a:off x="130099" y="2493684"/>
            <a:ext cx="21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8" name="Textfeld 27"/>
            <p:cNvSpPr txBox="1"/>
            <p:nvPr/>
          </p:nvSpPr>
          <p:spPr>
            <a:xfrm>
              <a:off x="-96532" y="212987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569481" y="4593717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1036995" y="4593717"/>
              <a:ext cx="5245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vir-88</a:t>
              </a: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148984" y="2150351"/>
              <a:ext cx="17506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in vitro 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appressoria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orphology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uppieren 5"/>
          <p:cNvGrpSpPr/>
          <p:nvPr/>
        </p:nvGrpSpPr>
        <p:grpSpPr>
          <a:xfrm>
            <a:off x="-39855" y="2129879"/>
            <a:ext cx="2404303" cy="2710059"/>
            <a:chOff x="2139190" y="2129879"/>
            <a:chExt cx="2404303" cy="2710059"/>
          </a:xfrm>
        </p:grpSpPr>
        <p:graphicFrame>
          <p:nvGraphicFramePr>
            <p:cNvPr id="73" name="Diagramm 7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14018518"/>
                </p:ext>
              </p:extLst>
            </p:nvPr>
          </p:nvGraphicFramePr>
          <p:xfrm>
            <a:off x="2383493" y="2493684"/>
            <a:ext cx="216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76" name="Textfeld 75"/>
            <p:cNvSpPr txBox="1"/>
            <p:nvPr/>
          </p:nvSpPr>
          <p:spPr>
            <a:xfrm>
              <a:off x="2830431" y="4593717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77" name="Textfeld 76"/>
            <p:cNvSpPr txBox="1"/>
            <p:nvPr/>
          </p:nvSpPr>
          <p:spPr>
            <a:xfrm>
              <a:off x="3290537" y="4593717"/>
              <a:ext cx="5245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vir-88</a:t>
              </a:r>
            </a:p>
          </p:txBody>
        </p:sp>
        <p:sp>
          <p:nvSpPr>
            <p:cNvPr id="2" name="Textfeld 1"/>
            <p:cNvSpPr txBox="1"/>
            <p:nvPr/>
          </p:nvSpPr>
          <p:spPr>
            <a:xfrm>
              <a:off x="2139190" y="212987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2408444" y="2150351"/>
              <a:ext cx="17506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in </a:t>
              </a:r>
              <a:r>
                <a:rPr lang="de-DE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</a:t>
              </a:r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appressoria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orphology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8" name="Textfeld 77"/>
          <p:cNvSpPr txBox="1"/>
          <p:nvPr/>
        </p:nvSpPr>
        <p:spPr>
          <a:xfrm>
            <a:off x="2878653" y="459371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9" name="Textfeld 78"/>
          <p:cNvSpPr txBox="1"/>
          <p:nvPr/>
        </p:nvSpPr>
        <p:spPr>
          <a:xfrm>
            <a:off x="3342671" y="4593717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vir-88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2209314" y="212987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2465258" y="2150351"/>
            <a:ext cx="17506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rimar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hypha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ormatio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uppieren 3"/>
          <p:cNvGrpSpPr/>
          <p:nvPr/>
        </p:nvGrpSpPr>
        <p:grpSpPr>
          <a:xfrm>
            <a:off x="-39855" y="8944"/>
            <a:ext cx="6865842" cy="1947754"/>
            <a:chOff x="-33832" y="2921967"/>
            <a:chExt cx="6865842" cy="1947754"/>
          </a:xfrm>
        </p:grpSpPr>
        <p:pic>
          <p:nvPicPr>
            <p:cNvPr id="9" name="Picture 2" descr="D:\Johannes\mob2 paper\Abbildungen\Figure S deformed ap\originale\vir88\Image1.jpg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790" t="43814" r="35232" b="39208"/>
            <a:stretch/>
          </p:blipFill>
          <p:spPr bwMode="auto">
            <a:xfrm>
              <a:off x="5998" y="2930645"/>
              <a:ext cx="1692001" cy="169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8" descr="D:\Johannes\_Mob2 vir88 _ 5971\Infektionen\2016-6-20 infektion vir88 3 dpi\vir-88\2-1\Image6.jpg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386" t="67920" r="25635" b="15101"/>
            <a:stretch/>
          </p:blipFill>
          <p:spPr bwMode="auto">
            <a:xfrm>
              <a:off x="3428673" y="2930645"/>
              <a:ext cx="1691999" cy="169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5" descr="D:\Johannes\mob2 paper\Abbildungen\Figure S deformed ap\originale\vir88\Image6.jpg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colorTemperature colorTemp="11500"/>
                      </a14:imgEffect>
                      <a14:imgEffect>
                        <a14:saturation sat="90000"/>
                      </a14:imgEffect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224" t="22828" r="62798" b="60194"/>
            <a:stretch/>
          </p:blipFill>
          <p:spPr bwMode="auto">
            <a:xfrm>
              <a:off x="5140010" y="2930645"/>
              <a:ext cx="1692000" cy="169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7" descr="D:\Johannes\mob2 paper\Abbildungen\Figure S deformed ap\originale\vir88\Image9.jpg"/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091" t="37145" r="39931" b="45876"/>
            <a:stretch/>
          </p:blipFill>
          <p:spPr bwMode="auto">
            <a:xfrm>
              <a:off x="1717336" y="2930645"/>
              <a:ext cx="1692000" cy="1692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Textfeld 12"/>
            <p:cNvSpPr txBox="1"/>
            <p:nvPr/>
          </p:nvSpPr>
          <p:spPr>
            <a:xfrm>
              <a:off x="5997" y="4615134"/>
              <a:ext cx="16920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normal appressoria</a:t>
              </a: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1717336" y="4615134"/>
              <a:ext cx="169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artly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melanized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nidia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5" name="Gleichschenkliges Dreieck 14"/>
            <p:cNvSpPr/>
            <p:nvPr/>
          </p:nvSpPr>
          <p:spPr>
            <a:xfrm rot="13177528">
              <a:off x="2121752" y="3909676"/>
              <a:ext cx="72000" cy="144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6" name="Gleichschenkliges Dreieck 15"/>
            <p:cNvSpPr/>
            <p:nvPr/>
          </p:nvSpPr>
          <p:spPr>
            <a:xfrm rot="19834754">
              <a:off x="1170073" y="3997004"/>
              <a:ext cx="72000" cy="144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" name="Gleichschenkliges Dreieck 16"/>
            <p:cNvSpPr/>
            <p:nvPr/>
          </p:nvSpPr>
          <p:spPr>
            <a:xfrm rot="1991850">
              <a:off x="4238671" y="4045444"/>
              <a:ext cx="72000" cy="14400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1102839" y="4101709"/>
              <a:ext cx="3399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H</a:t>
              </a: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2131225" y="3770692"/>
              <a:ext cx="3399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H</a:t>
              </a: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3428673" y="4623500"/>
              <a:ext cx="16919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melanized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germ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ube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5140010" y="4615133"/>
              <a:ext cx="1692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polarity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efects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-33832" y="292196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5" name="Gleichschenkliges Dreieck 34"/>
            <p:cNvSpPr/>
            <p:nvPr/>
          </p:nvSpPr>
          <p:spPr>
            <a:xfrm rot="13177528">
              <a:off x="2450112" y="4331974"/>
              <a:ext cx="72000" cy="14400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  <a:scene3d>
              <a:camera prst="orthographicFront">
                <a:rot lat="0" lon="0" rev="162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6" name="Gleichschenkliges Dreieck 35"/>
            <p:cNvSpPr/>
            <p:nvPr/>
          </p:nvSpPr>
          <p:spPr>
            <a:xfrm rot="13177528">
              <a:off x="2954168" y="3407746"/>
              <a:ext cx="72000" cy="14400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  <a:scene3d>
              <a:camera prst="orthographicFront">
                <a:rot lat="0" lon="0" rev="126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7" name="Gleichschenkliges Dreieck 36"/>
            <p:cNvSpPr/>
            <p:nvPr/>
          </p:nvSpPr>
          <p:spPr>
            <a:xfrm rot="1991850">
              <a:off x="5621596" y="4193268"/>
              <a:ext cx="72000" cy="14400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8" name="Gleichschenkliges Dreieck 37"/>
            <p:cNvSpPr/>
            <p:nvPr/>
          </p:nvSpPr>
          <p:spPr>
            <a:xfrm rot="1991850">
              <a:off x="6133575" y="3688297"/>
              <a:ext cx="72000" cy="144000"/>
            </a:xfrm>
            <a:prstGeom prst="triangle">
              <a:avLst/>
            </a:prstGeom>
            <a:solidFill>
              <a:schemeClr val="bg1"/>
            </a:solidFill>
            <a:ln>
              <a:noFill/>
            </a:ln>
            <a:scene3d>
              <a:camera prst="orthographicFront">
                <a:rot lat="0" lon="0" rev="1080000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39" name="Gerade Verbindung 38"/>
            <p:cNvCxnSpPr/>
            <p:nvPr/>
          </p:nvCxnSpPr>
          <p:spPr>
            <a:xfrm>
              <a:off x="1109657" y="4578151"/>
              <a:ext cx="525600" cy="0"/>
            </a:xfrm>
            <a:prstGeom prst="line">
              <a:avLst/>
            </a:prstGeom>
            <a:ln w="254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Gerade Verbindung 39"/>
            <p:cNvCxnSpPr/>
            <p:nvPr/>
          </p:nvCxnSpPr>
          <p:spPr>
            <a:xfrm>
              <a:off x="2820871" y="4578151"/>
              <a:ext cx="525600" cy="0"/>
            </a:xfrm>
            <a:prstGeom prst="line">
              <a:avLst/>
            </a:prstGeom>
            <a:ln w="254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rade Verbindung 40"/>
            <p:cNvCxnSpPr/>
            <p:nvPr/>
          </p:nvCxnSpPr>
          <p:spPr>
            <a:xfrm>
              <a:off x="4513005" y="4578151"/>
              <a:ext cx="525600" cy="0"/>
            </a:xfrm>
            <a:prstGeom prst="line">
              <a:avLst/>
            </a:prstGeom>
            <a:ln w="254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 Verbindung 41"/>
            <p:cNvCxnSpPr/>
            <p:nvPr/>
          </p:nvCxnSpPr>
          <p:spPr>
            <a:xfrm>
              <a:off x="6239122" y="4578151"/>
              <a:ext cx="525600" cy="0"/>
            </a:xfrm>
            <a:prstGeom prst="line">
              <a:avLst/>
            </a:prstGeom>
            <a:ln w="25400" cap="flat">
              <a:solidFill>
                <a:schemeClr val="tx1"/>
              </a:solidFill>
              <a:miter lim="800000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Rechteck 21"/>
          <p:cNvSpPr/>
          <p:nvPr/>
        </p:nvSpPr>
        <p:spPr>
          <a:xfrm>
            <a:off x="0" y="5082207"/>
            <a:ext cx="6859588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Arial"/>
                <a:ea typeface="Times New Roman"/>
                <a:cs typeface="Times New Roman"/>
              </a:rPr>
              <a:t>Additional file 1: Figure </a:t>
            </a:r>
            <a:r>
              <a:rPr lang="en-US" sz="1200" b="1">
                <a:latin typeface="Arial"/>
                <a:ea typeface="Times New Roman"/>
                <a:cs typeface="Times New Roman"/>
              </a:rPr>
              <a:t>S1.pptx. </a:t>
            </a:r>
            <a:r>
              <a:rPr lang="en-US" sz="1200" b="1" i="1" dirty="0">
                <a:latin typeface="Arial"/>
                <a:ea typeface="Times New Roman"/>
                <a:cs typeface="Times New Roman"/>
              </a:rPr>
              <a:t>vir-88 </a:t>
            </a:r>
            <a:r>
              <a:rPr lang="en-US" sz="1200" b="1" dirty="0">
                <a:latin typeface="Arial"/>
                <a:ea typeface="Times New Roman"/>
                <a:cs typeface="Times New Roman"/>
              </a:rPr>
              <a:t>produces irregularly shaped appressoria.</a:t>
            </a:r>
            <a:endParaRPr lang="de-DE" sz="1200" b="1" dirty="0">
              <a:latin typeface="Arial"/>
              <a:ea typeface="Times New Roman"/>
              <a:cs typeface="Times New Roman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latin typeface="Arial"/>
                <a:ea typeface="Calibri"/>
                <a:cs typeface="Times New Roman"/>
              </a:rPr>
              <a:t>(A) Trypan blue stained images of deformed appressoria from </a:t>
            </a:r>
            <a:r>
              <a:rPr lang="en-US" sz="1200" i="1" dirty="0">
                <a:latin typeface="Arial"/>
                <a:ea typeface="Calibri"/>
                <a:cs typeface="Times New Roman"/>
              </a:rPr>
              <a:t>vir-88</a:t>
            </a:r>
            <a:r>
              <a:rPr lang="en-US" sz="1200" dirty="0">
                <a:latin typeface="Arial"/>
                <a:ea typeface="Calibri"/>
                <a:cs typeface="Times New Roman"/>
              </a:rPr>
              <a:t> at 3 dpi. The respective phenotypes are highlighted by white arrows, while primary hyphae are marked with black arrows. Scale bars = 20 µm. (B) Quantification of obviously misshaped appressoria. (C) Fraction of primary hyphae that originated from normal or deformed appressoria at 3 dpi. The average of 5 plants with 2 leaves each and at least 100 appressoria counted per leaf is shown for (B) and (C). (D) Quantification of misshaped appressoria on artificial hydrophobic surface. The average of 3 separate plates with at least 200 appressoria counted per plate is given.</a:t>
            </a:r>
            <a:endParaRPr lang="de-DE" sz="1200" dirty="0">
              <a:effectLst/>
              <a:latin typeface="Arial"/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1000657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2</Words>
  <Application>Microsoft Office PowerPoint</Application>
  <PresentationFormat>Benutzerdefiniert</PresentationFormat>
  <Paragraphs>22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-Desig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hannes</dc:creator>
  <cp:lastModifiedBy>johannes.schmidpeter@altmuehlnet.de</cp:lastModifiedBy>
  <cp:revision>67</cp:revision>
  <cp:lastPrinted>2016-06-22T11:09:40Z</cp:lastPrinted>
  <dcterms:created xsi:type="dcterms:W3CDTF">2016-01-13T09:32:30Z</dcterms:created>
  <dcterms:modified xsi:type="dcterms:W3CDTF">2017-01-10T10:08:08Z</dcterms:modified>
</cp:coreProperties>
</file>